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38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290B63-183D-4E70-AEA2-5FD54FA80BBA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71F7AF-A1CB-40A5-BB4F-035E02EEA6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19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8AF95F-BF03-4BBD-B94A-036583A5085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8693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1717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433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118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2149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970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111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44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82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2663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490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154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1CE0D6-2031-4BB6-B42E-D8D34E3CF61B}" type="datetimeFigureOut">
              <a:rPr lang="en-US" smtClean="0"/>
              <a:t>3/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4735C-B12B-4A36-B347-4B1511703D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1194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5.tiff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tiff"/><Relationship Id="rId11" Type="http://schemas.openxmlformats.org/officeDocument/2006/relationships/oleObject" Target="../embeddings/oleObject1.bin"/><Relationship Id="rId5" Type="http://schemas.openxmlformats.org/officeDocument/2006/relationships/image" Target="../media/image3.tiff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07066" y="3478472"/>
            <a:ext cx="2652921" cy="2005943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323" y="4013192"/>
            <a:ext cx="1778136" cy="13284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0913" y="4012407"/>
            <a:ext cx="1779000" cy="132913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158962" y="3687417"/>
            <a:ext cx="19941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Negative contro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019412" y="3735912"/>
            <a:ext cx="16834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2">
                    <a:lumMod val="50000"/>
                  </a:schemeClr>
                </a:solidFill>
              </a:rPr>
              <a:t>siLINC00261 No.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888534" y="3735912"/>
            <a:ext cx="169228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2">
                    <a:lumMod val="50000"/>
                  </a:schemeClr>
                </a:solidFill>
              </a:rPr>
              <a:t>siLINC00261 No.2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9555" y="4012406"/>
            <a:ext cx="1779002" cy="13291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/>
          <p:cNvSpPr txBox="1"/>
          <p:nvPr/>
        </p:nvSpPr>
        <p:spPr>
          <a:xfrm>
            <a:off x="405641" y="3315907"/>
            <a:ext cx="15345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C-3 cells</a:t>
            </a: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040" y="476998"/>
            <a:ext cx="2889619" cy="2425072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6521" y="488023"/>
            <a:ext cx="3282271" cy="3022899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E4F05F8-D3C9-1149-A179-D6C930BD0EB0}"/>
              </a:ext>
            </a:extLst>
          </p:cNvPr>
          <p:cNvSpPr txBox="1"/>
          <p:nvPr/>
        </p:nvSpPr>
        <p:spPr>
          <a:xfrm>
            <a:off x="148209" y="407648"/>
            <a:ext cx="350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A8F48A7-1147-9249-89D8-AF6E6CE980D9}"/>
              </a:ext>
            </a:extLst>
          </p:cNvPr>
          <p:cNvSpPr txBox="1"/>
          <p:nvPr/>
        </p:nvSpPr>
        <p:spPr>
          <a:xfrm>
            <a:off x="3251084" y="407648"/>
            <a:ext cx="350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A798948-FDEB-7445-A582-25159CB99BE7}"/>
              </a:ext>
            </a:extLst>
          </p:cNvPr>
          <p:cNvSpPr txBox="1"/>
          <p:nvPr/>
        </p:nvSpPr>
        <p:spPr>
          <a:xfrm>
            <a:off x="6999811" y="407648"/>
            <a:ext cx="350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25E78B3-F4CE-104C-949F-64FE15B35871}"/>
              </a:ext>
            </a:extLst>
          </p:cNvPr>
          <p:cNvSpPr txBox="1"/>
          <p:nvPr/>
        </p:nvSpPr>
        <p:spPr>
          <a:xfrm>
            <a:off x="142486" y="3198244"/>
            <a:ext cx="350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D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23FACEC-2F26-5B4F-898B-1AD2A4D413F3}"/>
              </a:ext>
            </a:extLst>
          </p:cNvPr>
          <p:cNvSpPr txBox="1"/>
          <p:nvPr/>
        </p:nvSpPr>
        <p:spPr>
          <a:xfrm>
            <a:off x="5846838" y="3198244"/>
            <a:ext cx="350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9F9D21C-464C-0745-AA5A-8500BFB07747}"/>
              </a:ext>
            </a:extLst>
          </p:cNvPr>
          <p:cNvSpPr txBox="1"/>
          <p:nvPr/>
        </p:nvSpPr>
        <p:spPr>
          <a:xfrm>
            <a:off x="9063991" y="5383843"/>
            <a:ext cx="15345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U-145 cells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0685" y="559660"/>
            <a:ext cx="2840101" cy="2259748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54598" y="85033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ry figure 2</a:t>
            </a:r>
            <a:endParaRPr lang="en-US" dirty="0"/>
          </a:p>
        </p:txBody>
      </p:sp>
      <p:graphicFrame>
        <p:nvGraphicFramePr>
          <p:cNvPr id="23" name="Object 22"/>
          <p:cNvGraphicFramePr>
            <a:graphicFrameLocks noChangeAspect="1"/>
          </p:cNvGraphicFramePr>
          <p:nvPr>
            <p:extLst/>
          </p:nvPr>
        </p:nvGraphicFramePr>
        <p:xfrm>
          <a:off x="5889625" y="3330575"/>
          <a:ext cx="2624138" cy="2495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7" r:id="rId11" imgW="3514204" imgH="3338988" progId="Prism7.Document">
                  <p:embed/>
                </p:oleObj>
              </mc:Choice>
              <mc:Fallback>
                <p:oleObj name="Prism 7" r:id="rId11" imgW="3514204" imgH="3338988" progId="Prism7.Document">
                  <p:embed/>
                  <p:pic>
                    <p:nvPicPr>
                      <p:cNvPr id="23" name="Object 2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889625" y="3330575"/>
                        <a:ext cx="2624138" cy="249555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id="{F9F9D21C-464C-0745-AA5A-8500BFB07747}"/>
              </a:ext>
            </a:extLst>
          </p:cNvPr>
          <p:cNvSpPr txBox="1"/>
          <p:nvPr/>
        </p:nvSpPr>
        <p:spPr>
          <a:xfrm>
            <a:off x="6252204" y="5457356"/>
            <a:ext cx="15345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C-3 </a:t>
            </a:r>
            <a:r>
              <a:rPr lang="en-US" dirty="0"/>
              <a:t>cell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23FACEC-2F26-5B4F-898B-1AD2A4D413F3}"/>
              </a:ext>
            </a:extLst>
          </p:cNvPr>
          <p:cNvSpPr txBox="1"/>
          <p:nvPr/>
        </p:nvSpPr>
        <p:spPr>
          <a:xfrm>
            <a:off x="8500676" y="3198244"/>
            <a:ext cx="3508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9955820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Office PowerPoint</Application>
  <PresentationFormat>Widescreen</PresentationFormat>
  <Paragraphs>15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7</vt:lpstr>
      <vt:lpstr>PowerPoint Presentation</vt:lpstr>
    </vt:vector>
  </TitlesOfParts>
  <Company>University of Michigan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olia, Abhijit</dc:creator>
  <cp:lastModifiedBy>Parolia, Abhijit</cp:lastModifiedBy>
  <cp:revision>1</cp:revision>
  <dcterms:created xsi:type="dcterms:W3CDTF">2021-03-09T01:07:09Z</dcterms:created>
  <dcterms:modified xsi:type="dcterms:W3CDTF">2021-03-09T01:07:16Z</dcterms:modified>
</cp:coreProperties>
</file>